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74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3569DF-7F3D-D64A-5043-751670C4E1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4250281-F588-ABDA-E7B2-6B6553D96A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19C6FE-0CB2-E99E-9DF6-3C8ECEEE0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6704DA-50FB-801D-E8C1-A6E10860F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9BED12-78E4-0B0F-2268-09D93B0BD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851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070308-97E2-DD2E-ECE1-6544181996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BD70A1-5AAD-E61C-2DCB-FB9948506E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3C55F-5BA0-E0CE-7E25-D034D49D9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76436-4900-E1E7-7E7B-8B4077FF6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722738-FB17-5B5B-3AF5-F0D304A46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246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59811C-561A-9AE6-ED42-128BC8FA14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54DA3F-D756-D042-DA3A-A722D713F7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FC5F6A-5005-7306-5495-36E23276D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4E1C63-C5C9-8701-041D-4548EC55E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50C31A-3218-EF00-24CC-449A44F4A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797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087E77-6783-DC7F-2356-BDB845C28B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D3B43A-245C-AD18-41D9-BDB8701C7D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0B62A3-507F-E500-9C9C-8F3C63D38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67C597-241E-CAB1-E76A-D6B025E92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2AACC9-2285-F533-3049-F903E223B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651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20D3F6-90B3-424C-CBAC-70D0C4620C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921663-A7D7-7051-90F4-1A1A8798DD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E59F88-4DFD-5349-AC02-6BF02EFB3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2CE7B7-A3B8-8F10-B7AF-C286B016F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B59994-3FCA-A33E-3CE4-AB81D335F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865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CF66C6-EB3A-0D1A-5FE3-92D9BBDE95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8CD3D6-E821-694A-CDEA-39012B0FF4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A73ED9-0E2E-4D8C-8A8D-E4DA30DE2D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F95CD0-AB6A-DC5E-478F-B3D20CAD2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683A07-03A3-AAA8-7D12-77C673111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49F37D-4E91-9609-0A05-745DFA9AF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684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5F890-F146-20D6-794B-F6A34714D9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0D4D69-921D-D1A8-BB4F-70E539E722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536D33-13E8-38C3-FBD8-29F028420D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35FB67-23BA-CB47-7FDF-26B74D12CF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B40AFF1-E98F-EF7F-29B2-F530E5505E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A2EEE9-4603-9605-B567-09DDCA2BCA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EA27BC1-D7AE-F827-66AD-DA263C6A5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8DC0DC6-607D-C1B4-8F00-7DBF78D1B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431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D3AD3F-A504-19FB-150B-66262A4C16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7D8255-846C-C38D-5ACB-0AEFE51FF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B5B369-FB78-265C-5D9D-90BA072AB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D2DFA1-8E9B-FDC6-EB4E-A29A4E97AA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345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2B2F275-05AD-3671-F7E2-978EBFA63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9AF890-C795-D9C0-1810-EDBCDA61F9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445CF4-B96F-F98D-EBF4-D0A9BB1DAB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42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0F647A-2F42-EB6C-7502-5F48D789B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B78663-EF2F-768C-6CA1-F787D162FF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C674C1-77E0-F1A6-3B3B-AEA45158D9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62D7AE-6682-C716-4E0E-63A4B708B1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51608A-ACD3-A76A-FEBA-B7AD8E789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86C358-3F11-D323-1CC1-4BBEDF1AC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630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5B4DF7-C171-3BD5-591F-D39A44BEA2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59DE0D-3691-47B6-09FD-EBE70F4248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C00CF4-7C3B-406F-F7CE-1AA1948468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2BD086-EE57-DF2D-7DA6-32CBC2393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EFCE87-CC2C-47DF-73DF-10C8AF4C94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734915-D678-8F83-83F6-6C3CDF6F9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620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A531415-A923-9F31-D4DE-5E6D7C4E7C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E14A63-4420-5AB3-F398-176A40614C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3FEAA4-79A0-5F2D-ADED-87CEB1B244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68051E2-8B7C-4096-8470-3D9208DFDF99}" type="datetimeFigureOut">
              <a:rPr lang="en-US" smtClean="0"/>
              <a:t>10/0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455E54-20F2-1415-771D-9E920F40C6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B98AF8-016F-FB51-3D7B-AB9AA8EC3B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4C2514-CD84-4DB2-AD3D-5BF03CBCA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042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AECE5F0-C250-0C89-C629-CE50CEE0F9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9522146"/>
              </p:ext>
            </p:extLst>
          </p:nvPr>
        </p:nvGraphicFramePr>
        <p:xfrm>
          <a:off x="1640018" y="643466"/>
          <a:ext cx="8911967" cy="6024735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651241">
                  <a:extLst>
                    <a:ext uri="{9D8B030D-6E8A-4147-A177-3AD203B41FA5}">
                      <a16:colId xmlns:a16="http://schemas.microsoft.com/office/drawing/2014/main" val="3914644905"/>
                    </a:ext>
                  </a:extLst>
                </a:gridCol>
                <a:gridCol w="1921692">
                  <a:extLst>
                    <a:ext uri="{9D8B030D-6E8A-4147-A177-3AD203B41FA5}">
                      <a16:colId xmlns:a16="http://schemas.microsoft.com/office/drawing/2014/main" val="250684247"/>
                    </a:ext>
                  </a:extLst>
                </a:gridCol>
                <a:gridCol w="389233">
                  <a:extLst>
                    <a:ext uri="{9D8B030D-6E8A-4147-A177-3AD203B41FA5}">
                      <a16:colId xmlns:a16="http://schemas.microsoft.com/office/drawing/2014/main" val="2723172391"/>
                    </a:ext>
                  </a:extLst>
                </a:gridCol>
                <a:gridCol w="3393833">
                  <a:extLst>
                    <a:ext uri="{9D8B030D-6E8A-4147-A177-3AD203B41FA5}">
                      <a16:colId xmlns:a16="http://schemas.microsoft.com/office/drawing/2014/main" val="3625928371"/>
                    </a:ext>
                  </a:extLst>
                </a:gridCol>
                <a:gridCol w="1146981">
                  <a:extLst>
                    <a:ext uri="{9D8B030D-6E8A-4147-A177-3AD203B41FA5}">
                      <a16:colId xmlns:a16="http://schemas.microsoft.com/office/drawing/2014/main" val="3412831733"/>
                    </a:ext>
                  </a:extLst>
                </a:gridCol>
                <a:gridCol w="1408987">
                  <a:extLst>
                    <a:ext uri="{9D8B030D-6E8A-4147-A177-3AD203B41FA5}">
                      <a16:colId xmlns:a16="http://schemas.microsoft.com/office/drawing/2014/main" val="3040599054"/>
                    </a:ext>
                  </a:extLst>
                </a:gridCol>
              </a:tblGrid>
              <a:tr h="207607">
                <a:tc gridSpan="6"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400" u="none" strike="noStrike" dirty="0">
                          <a:effectLst/>
                        </a:rPr>
                        <a:t>Table 2: Clinical and Laboratory Course by Treatment Day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0528957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PT (Prothrombin Time, Sec.)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Hg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APTT (Activated Partial Thromboplastin Time, Sec.)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Interventio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Factor V Activity (%)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ctr"/>
                </a:tc>
                <a:extLst>
                  <a:ext uri="{0D108BD9-81ED-4DB2-BD59-A6C34878D82A}">
                    <a16:rowId xmlns:a16="http://schemas.microsoft.com/office/drawing/2014/main" val="3271071533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6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9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gt;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873530287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62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gt;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FFP + Vit k Dail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lt;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170394280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59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7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8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FVIIa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605161967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2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6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41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FVIIa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965840778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7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61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Platelet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2503110457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29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6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99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Platelet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2033579811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7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6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gt;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34785693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5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gt;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00280993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59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6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gt;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522542079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8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6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78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ituxima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2844132022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54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69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2714650597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57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gt;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lt;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309958220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58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gt;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3521852900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58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7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gt;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IVIG x 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305970483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59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&gt;2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3693486823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7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00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012534945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56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9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ituximab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3436199417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38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7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3660832193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2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7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16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742106883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26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7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65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2283055646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8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7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4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2163098749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7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5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2377380962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4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35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858760869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7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5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ituxima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4200826042"/>
                  </a:ext>
                </a:extLst>
              </a:tr>
              <a:tr h="157749">
                <a:tc gridSpan="4"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Beginning of monthly treatment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3165071324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4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8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35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ituxima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2941781476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2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9.7</a:t>
                      </a: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33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ituxima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3990154926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3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0.4</a:t>
                      </a: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34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ituxima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536953498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2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3.3</a:t>
                      </a: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33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ituxima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1333797827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4.2</a:t>
                      </a: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32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ituxima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3376654825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7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1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4.5</a:t>
                      </a: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ituxima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732553980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Day 1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11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4.4</a:t>
                      </a: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 dirty="0">
                          <a:effectLst/>
                        </a:rPr>
                        <a:t>28.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 dirty="0">
                          <a:effectLst/>
                        </a:rPr>
                        <a:t>Rituximab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 dirty="0">
                          <a:effectLst/>
                        </a:rPr>
                        <a:t>7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2660189329"/>
                  </a:ext>
                </a:extLst>
              </a:tr>
              <a:tr h="15774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100" u="none" strike="noStrike" dirty="0">
                          <a:effectLst/>
                        </a:rPr>
                        <a:t>Day 22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 dirty="0">
                          <a:effectLst/>
                        </a:rPr>
                        <a:t>11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 dirty="0">
                          <a:effectLst/>
                        </a:rPr>
                        <a:t>14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31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>
                          <a:effectLst/>
                        </a:rPr>
                        <a:t>Rituxima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u="none" strike="noStrike" dirty="0">
                          <a:effectLst/>
                        </a:rPr>
                        <a:t>7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189" marR="3189" marT="3189" marB="0" anchor="b"/>
                </a:tc>
                <a:extLst>
                  <a:ext uri="{0D108BD9-81ED-4DB2-BD59-A6C34878D82A}">
                    <a16:rowId xmlns:a16="http://schemas.microsoft.com/office/drawing/2014/main" val="32416935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63317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77</Words>
  <Application>Microsoft Office PowerPoint</Application>
  <PresentationFormat>Widescreen</PresentationFormat>
  <Paragraphs>20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ptos Narrow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lantri, Shreyas</dc:creator>
  <cp:lastModifiedBy>Kalantri, Shreyas</cp:lastModifiedBy>
  <cp:revision>3</cp:revision>
  <dcterms:created xsi:type="dcterms:W3CDTF">2025-10-02T15:18:51Z</dcterms:created>
  <dcterms:modified xsi:type="dcterms:W3CDTF">2025-10-02T15:23:50Z</dcterms:modified>
</cp:coreProperties>
</file>